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sldIdLst>
    <p:sldId id="262" r:id="rId5"/>
  </p:sldIdLst>
  <p:sldSz cx="12192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amegowda" initials="HV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434" autoAdjust="0"/>
  </p:normalViewPr>
  <p:slideViewPr>
    <p:cSldViewPr snapToGrid="0">
      <p:cViewPr>
        <p:scale>
          <a:sx n="75" d="100"/>
          <a:sy n="75" d="100"/>
        </p:scale>
        <p:origin x="516" y="-3456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532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178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120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388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767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223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483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016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498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252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346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405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8544" y="10103990"/>
            <a:ext cx="1095491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tabolism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verview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ap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owing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fferences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anscript levels of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mbined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rought and heat stressed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. thaliana plants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The figure i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enerated using MapMan software and is bas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vided b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izhsk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. (2004) Plant Physiol. 134 (4), 1683-1696. Th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ata (fold change expression values) we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aded into the MapMan Image Annotato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dule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 generate the metabolism overview map. On the logarithmic colo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cale ranging from 4.5 to -4,5, gree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present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p-regulated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r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present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own-regulated transcripts.</a:t>
            </a:r>
          </a:p>
          <a:p>
            <a:pPr algn="just">
              <a:lnSpc>
                <a:spcPct val="150000"/>
              </a:lnSpc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437" t="824" r="23961"/>
          <a:stretch/>
        </p:blipFill>
        <p:spPr>
          <a:xfrm>
            <a:off x="1173067" y="1972491"/>
            <a:ext cx="9910670" cy="72588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22930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3.PPTX</TitleName>
    <StageName xmlns="ad5e6ac6-7e28-44ff-b599-4b096ee3745e" xsi:nil="true"/>
    <DocumentType xmlns="ad5e6ac6-7e28-44ff-b599-4b096ee3745e">Presentation</DocumentType>
    <DocumentId xmlns="ad5e6ac6-7e28-44ff-b599-4b096ee3745e">Presentation 3.PPTX</DocumentId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57116F4-B13C-4CA4-8911-4FC7A46B80F8}">
  <ds:schemaRefs>
    <ds:schemaRef ds:uri="http://purl.org/dc/terms/"/>
    <ds:schemaRef ds:uri="http://www.w3.org/XML/1998/namespace"/>
    <ds:schemaRef ds:uri="http://purl.org/dc/dcmitype/"/>
    <ds:schemaRef ds:uri="http://purl.org/dc/elements/1.1/"/>
    <ds:schemaRef ds:uri="http://schemas.microsoft.com/office/2006/documentManagement/types"/>
    <ds:schemaRef ds:uri="http://schemas.openxmlformats.org/package/2006/metadata/core-properties"/>
    <ds:schemaRef ds:uri="ad5e6ac6-7e28-44ff-b599-4b096ee3745e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1309251B-3DE4-4CEF-9CC2-A14E7D335CC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d5e6ac6-7e28-44ff-b599-4b096ee3745e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701BF3F9-B467-466B-B2BC-7501C47FBEB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9</TotalTime>
  <Words>2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Senthil-Kumar Muthappa</cp:lastModifiedBy>
  <cp:revision>48</cp:revision>
  <dcterms:created xsi:type="dcterms:W3CDTF">2015-06-03T08:23:24Z</dcterms:created>
  <dcterms:modified xsi:type="dcterms:W3CDTF">2015-08-04T11:24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